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4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275A79-1B61-443C-B26C-9D86163B63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80FFD37-8BC8-4582-83AE-9196555067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84A9819-5C54-4D95-BB3A-9C3E0B847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C42E29B-F7F7-4DE3-8F73-4F9B6487B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5B1C280-3BD9-416C-BE3F-080907F2F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1765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9C1443-E995-40AF-B3CA-B049270951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C33244B-40E3-46BC-9385-CFA9F468DD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3189EC2-CF42-493F-AB07-DA8C286C1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6AA00F5-10A9-48D5-A199-A556318B2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D77FC8A-40B5-44C6-A4D8-A5C0302A0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9749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81CE3F3-8788-4161-91AB-6BA754A299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E426D62-2CFC-46F8-8AF2-C6EC84498D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AB86538-2F08-4D36-83DD-F1769C1C7F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971A0C-88AE-4802-A337-B2591640B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A04C0BD-A51B-40B9-8824-4AAC501B9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6710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86B97C-5524-4358-ACE5-0992E9F5F5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B96D63D-C6B9-48E4-888A-6D33DB57A3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C038297-7AF7-4A5B-A396-96B3B6352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264C217-B423-4F24-ABB7-82837DECD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A34BD48-1A64-4B38-8732-D9C9C73D6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9698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47F280E-4C8E-4505-9AE9-F22A8E2ED9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61B06FA-1955-4006-A835-653F5C71C7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65C3D17-E7A9-436D-9463-81AB795DF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9B2C8B8-CF8C-447C-82EA-100B4C20A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55C326D-5CC6-45DB-BC2F-C9881268B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498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25623F5-7B72-4AB7-A6BA-E414F67EBF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6E34042-6F3E-423E-A930-A186066ECA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1CBD0F0-1B5A-4DB5-9D21-CBD24E86F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F34DD8C-D83E-4869-9D4D-29493F7E3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5484001-0070-4573-82E6-9813AC2F9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05DD430-09E4-4499-8C53-F006A4BB9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049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ABAAAB5-2161-4235-AE90-7E86578B0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0CCFD28-B067-4DE4-AAC8-BE2C027A5F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86C811F-683D-4F36-ABC6-A364E88738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76EBAAC-5237-4DF0-A678-1B647156BE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3A92DA5-6BF0-4BEE-B9DA-58B282F17B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EDDB5AE-5416-4F90-A3F4-75A834F7D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6C9D88F-80C1-4507-BC81-804C723AA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13C88AE-0324-47DD-8046-DE1D25698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6298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C5A4A9A-A713-4D56-A2A3-82EC91950C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A9B48CF-10CE-421C-8566-2CC54ECB4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FF44579-CDA1-43FA-923C-B863F2D1A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0E0493D-2F7A-4D27-8F77-14E52F070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8829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B33A59B-FCA9-49E5-BE70-35B653C49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FDFE6B9-EA5D-48FB-8E83-B898FE415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D9500D0-CE49-46E9-9E53-4BB78BFC7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321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B29E805-CDAC-4E99-89E8-2B049F2A20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43CDFE8-A372-4DCB-A7F8-A0253B0661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80EC986-B796-41E8-97BE-28975F25DD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4EF4987-1DC2-4C0B-B6CC-4F61A462A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6A9E2FB-822B-4BCD-890C-3EF644458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C3ABB4F-48FC-4C58-A271-29FB76B8D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1496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677DA6-B728-4C00-A630-5365ED9A3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C1335A6-1514-471D-B7B8-616DC1E1FA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882C7B6-6C10-4C57-9163-E23219ED77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1524F74-41C4-4D5C-A29D-D32D3510E8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6E542E6-5A6D-4030-B7B9-CE45D94BB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8449DB7-ABAD-4D80-A71D-0F0387538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0017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ECD80E2-8934-42F7-84D6-BE7B1942F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D5AB46A-41E7-4E2F-9651-09B2066B8D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759BF82-910E-440F-80FF-BBB01D42E3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A1F1C-3B5F-4F3C-8FBB-45BEBDE433E9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92859EE-3CCF-4CC1-A4B6-7337F79C58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6C44729-775D-4232-9770-137704D10A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5E0FE5-15BC-4D1E-87FD-F0D8B28164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9209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77A41AC4-162D-419D-B45E-8DFBA92FE0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941" y="1891830"/>
            <a:ext cx="3248025" cy="260032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5501790-4E0E-488B-83FD-ECAB82259B2E}"/>
              </a:ext>
            </a:extLst>
          </p:cNvPr>
          <p:cNvSpPr txBox="1"/>
          <p:nvPr/>
        </p:nvSpPr>
        <p:spPr>
          <a:xfrm rot="16200000">
            <a:off x="1481558" y="-371590"/>
            <a:ext cx="1998460" cy="2516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/>
              <a:t>4T1 </a:t>
            </a:r>
          </a:p>
          <a:p>
            <a:endParaRPr lang="fr-FR" sz="1050" dirty="0"/>
          </a:p>
          <a:p>
            <a:endParaRPr lang="fr-FR" sz="1050" dirty="0"/>
          </a:p>
          <a:p>
            <a:r>
              <a:rPr lang="fr-FR" sz="1050" dirty="0"/>
              <a:t>4T1 +200 </a:t>
            </a:r>
            <a:r>
              <a:rPr lang="fr-FR" sz="1050" dirty="0" err="1"/>
              <a:t>ug</a:t>
            </a:r>
            <a:r>
              <a:rPr lang="fr-FR" sz="1050" dirty="0"/>
              <a:t>/</a:t>
            </a:r>
            <a:r>
              <a:rPr lang="fr-FR" sz="1050" dirty="0" err="1"/>
              <a:t>mL</a:t>
            </a:r>
            <a:r>
              <a:rPr lang="fr-FR" sz="1050" dirty="0"/>
              <a:t> </a:t>
            </a:r>
            <a:r>
              <a:rPr lang="fr-FR" sz="1050" dirty="0" err="1"/>
              <a:t>héparinase</a:t>
            </a:r>
            <a:endParaRPr lang="fr-FR" sz="1050" dirty="0"/>
          </a:p>
          <a:p>
            <a:endParaRPr lang="fr-FR" sz="1050" dirty="0"/>
          </a:p>
          <a:p>
            <a:endParaRPr lang="fr-FR" sz="1050" dirty="0"/>
          </a:p>
          <a:p>
            <a:endParaRPr lang="fr-FR" sz="1050" dirty="0"/>
          </a:p>
          <a:p>
            <a:endParaRPr lang="fr-FR" sz="1050" dirty="0"/>
          </a:p>
          <a:p>
            <a:endParaRPr lang="fr-FR" sz="1050" dirty="0"/>
          </a:p>
          <a:p>
            <a:r>
              <a:rPr lang="fr-FR" sz="1050" dirty="0"/>
              <a:t>EMT6</a:t>
            </a:r>
          </a:p>
          <a:p>
            <a:endParaRPr lang="fr-FR" sz="1050" dirty="0"/>
          </a:p>
          <a:p>
            <a:endParaRPr lang="fr-FR" sz="1050" dirty="0"/>
          </a:p>
          <a:p>
            <a:r>
              <a:rPr lang="fr-FR" sz="1050" dirty="0"/>
              <a:t>EMT6 +200 </a:t>
            </a:r>
            <a:r>
              <a:rPr lang="fr-FR" sz="1050" dirty="0" err="1"/>
              <a:t>ug</a:t>
            </a:r>
            <a:r>
              <a:rPr lang="fr-FR" sz="1050" dirty="0"/>
              <a:t>/</a:t>
            </a:r>
            <a:r>
              <a:rPr lang="fr-FR" sz="1050" dirty="0" err="1"/>
              <a:t>mL</a:t>
            </a:r>
            <a:r>
              <a:rPr lang="fr-FR" sz="1050" dirty="0"/>
              <a:t> </a:t>
            </a:r>
            <a:r>
              <a:rPr lang="fr-FR" sz="1050" dirty="0" err="1"/>
              <a:t>héparinase</a:t>
            </a:r>
            <a:endParaRPr lang="fr-FR" sz="1050" dirty="0"/>
          </a:p>
          <a:p>
            <a:endParaRPr lang="fr-FR" sz="1050" dirty="0"/>
          </a:p>
          <a:p>
            <a:endParaRPr lang="fr-FR" sz="1050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7FFEFE60-7B2C-4FB8-95D9-2094DD151FB5}"/>
              </a:ext>
            </a:extLst>
          </p:cNvPr>
          <p:cNvSpPr txBox="1"/>
          <p:nvPr/>
        </p:nvSpPr>
        <p:spPr>
          <a:xfrm>
            <a:off x="4078471" y="2485812"/>
            <a:ext cx="9479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Netrin-1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7D0D068B-C710-48FE-8FC6-164354D2B7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96779" y="2126310"/>
            <a:ext cx="3248025" cy="2365845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25174B7F-D387-472A-BD2F-6D2CFDD47951}"/>
              </a:ext>
            </a:extLst>
          </p:cNvPr>
          <p:cNvSpPr txBox="1"/>
          <p:nvPr/>
        </p:nvSpPr>
        <p:spPr>
          <a:xfrm>
            <a:off x="8944804" y="3209645"/>
            <a:ext cx="9479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Actine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3628BA3B-6BFD-4274-85B8-0E99D39911B8}"/>
              </a:ext>
            </a:extLst>
          </p:cNvPr>
          <p:cNvSpPr txBox="1"/>
          <p:nvPr/>
        </p:nvSpPr>
        <p:spPr>
          <a:xfrm rot="16200000">
            <a:off x="6398893" y="-194022"/>
            <a:ext cx="1998460" cy="2516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/>
              <a:t>4T1 </a:t>
            </a:r>
          </a:p>
          <a:p>
            <a:endParaRPr lang="fr-FR" sz="1050" dirty="0"/>
          </a:p>
          <a:p>
            <a:endParaRPr lang="fr-FR" sz="1050" dirty="0"/>
          </a:p>
          <a:p>
            <a:r>
              <a:rPr lang="fr-FR" sz="1050" dirty="0"/>
              <a:t>4T1 +200 </a:t>
            </a:r>
            <a:r>
              <a:rPr lang="fr-FR" sz="1050" dirty="0" err="1"/>
              <a:t>ug</a:t>
            </a:r>
            <a:r>
              <a:rPr lang="fr-FR" sz="1050" dirty="0"/>
              <a:t>/</a:t>
            </a:r>
            <a:r>
              <a:rPr lang="fr-FR" sz="1050" dirty="0" err="1"/>
              <a:t>mL</a:t>
            </a:r>
            <a:r>
              <a:rPr lang="fr-FR" sz="1050" dirty="0"/>
              <a:t> </a:t>
            </a:r>
            <a:r>
              <a:rPr lang="fr-FR" sz="1050" dirty="0" err="1"/>
              <a:t>héparinase</a:t>
            </a:r>
            <a:endParaRPr lang="fr-FR" sz="1050" dirty="0"/>
          </a:p>
          <a:p>
            <a:endParaRPr lang="fr-FR" sz="1050" dirty="0"/>
          </a:p>
          <a:p>
            <a:endParaRPr lang="fr-FR" sz="1050" dirty="0"/>
          </a:p>
          <a:p>
            <a:endParaRPr lang="fr-FR" sz="1050" dirty="0"/>
          </a:p>
          <a:p>
            <a:endParaRPr lang="fr-FR" sz="1050" dirty="0"/>
          </a:p>
          <a:p>
            <a:endParaRPr lang="fr-FR" sz="1050" dirty="0"/>
          </a:p>
          <a:p>
            <a:r>
              <a:rPr lang="fr-FR" sz="1050" dirty="0"/>
              <a:t>EMT6</a:t>
            </a:r>
          </a:p>
          <a:p>
            <a:endParaRPr lang="fr-FR" sz="1050" dirty="0"/>
          </a:p>
          <a:p>
            <a:endParaRPr lang="fr-FR" sz="1050" dirty="0"/>
          </a:p>
          <a:p>
            <a:r>
              <a:rPr lang="fr-FR" sz="1050" dirty="0"/>
              <a:t>EMT6 +200 </a:t>
            </a:r>
            <a:r>
              <a:rPr lang="fr-FR" sz="1050" dirty="0" err="1"/>
              <a:t>ug</a:t>
            </a:r>
            <a:r>
              <a:rPr lang="fr-FR" sz="1050" dirty="0"/>
              <a:t>/</a:t>
            </a:r>
            <a:r>
              <a:rPr lang="fr-FR" sz="1050" dirty="0" err="1"/>
              <a:t>mL</a:t>
            </a:r>
            <a:r>
              <a:rPr lang="fr-FR" sz="1050" dirty="0"/>
              <a:t> </a:t>
            </a:r>
            <a:r>
              <a:rPr lang="fr-FR" sz="1050" dirty="0" err="1"/>
              <a:t>héparinase</a:t>
            </a:r>
            <a:endParaRPr lang="fr-FR" sz="1050" dirty="0"/>
          </a:p>
          <a:p>
            <a:endParaRPr lang="fr-FR" sz="1050" dirty="0"/>
          </a:p>
          <a:p>
            <a:endParaRPr lang="fr-FR" sz="1050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67127864-E797-4D2D-B62D-A89DEB73AF73}"/>
              </a:ext>
            </a:extLst>
          </p:cNvPr>
          <p:cNvSpPr txBox="1"/>
          <p:nvPr/>
        </p:nvSpPr>
        <p:spPr>
          <a:xfrm>
            <a:off x="26589" y="2269096"/>
            <a:ext cx="9479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75 kDa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0F003B0A-8249-4DCA-B099-8A345D22F231}"/>
              </a:ext>
            </a:extLst>
          </p:cNvPr>
          <p:cNvSpPr txBox="1"/>
          <p:nvPr/>
        </p:nvSpPr>
        <p:spPr>
          <a:xfrm>
            <a:off x="5026427" y="3100224"/>
            <a:ext cx="9479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45 kDa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8F5D5F1-311A-45C1-8FDB-88B9298A95DF}"/>
              </a:ext>
            </a:extLst>
          </p:cNvPr>
          <p:cNvSpPr/>
          <p:nvPr/>
        </p:nvSpPr>
        <p:spPr>
          <a:xfrm>
            <a:off x="855677" y="2269096"/>
            <a:ext cx="2718033" cy="65866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67D5F2B-7EBE-43D3-9692-52991EF0BF71}"/>
              </a:ext>
            </a:extLst>
          </p:cNvPr>
          <p:cNvSpPr/>
          <p:nvPr/>
        </p:nvSpPr>
        <p:spPr>
          <a:xfrm>
            <a:off x="5696780" y="3100224"/>
            <a:ext cx="2855228" cy="473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57475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8</Words>
  <Application>Microsoft Office PowerPoint</Application>
  <PresentationFormat>Grand écran</PresentationFormat>
  <Paragraphs>3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thieu richaud</dc:creator>
  <cp:lastModifiedBy>mathieu richaud</cp:lastModifiedBy>
  <cp:revision>1</cp:revision>
  <dcterms:created xsi:type="dcterms:W3CDTF">2022-10-14T13:48:51Z</dcterms:created>
  <dcterms:modified xsi:type="dcterms:W3CDTF">2022-10-14T13:51:02Z</dcterms:modified>
</cp:coreProperties>
</file>